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08"/>
    <p:restoredTop sz="91466"/>
  </p:normalViewPr>
  <p:slideViewPr>
    <p:cSldViewPr snapToGrid="0" snapToObjects="1">
      <p:cViewPr varScale="1">
        <p:scale>
          <a:sx n="66" d="100"/>
          <a:sy n="66" d="100"/>
        </p:scale>
        <p:origin x="87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E2C4B83-FDF8-B244-9CB9-2B8E84C0E86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F482963-52C0-FE48-8A6C-4BC6EC748DA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14AF6F8-85F2-4C4E-80C0-737BD84A01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FBEDD6-49DC-654A-A168-4B0CCC870FD8}" type="datetimeFigureOut">
              <a:rPr lang="en-US" smtClean="0"/>
              <a:t>6/17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6293E02-073D-A641-95E9-A7EE458EB5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D9EBD89-01B4-A542-AAFC-F0D3581F12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764CBB-9AFA-824B-8396-095C3D994F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18959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A6A224C-7A0A-BA4E-8687-A0C59645A0E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4F6BEA7-772F-254A-B76A-01A9D5CBEC4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DD0DF32-5F78-734E-B391-998AF69AB4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FBEDD6-49DC-654A-A168-4B0CCC870FD8}" type="datetimeFigureOut">
              <a:rPr lang="en-US" smtClean="0"/>
              <a:t>6/17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EEDB5FF-38A3-6F4F-BDBA-F7ED60EBA6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D8571C0-90FC-9540-982C-C47DB8880A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764CBB-9AFA-824B-8396-095C3D994F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7974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B58454D-6448-D842-A2F5-4E0FF5DE441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1926FD7-40A1-3C4F-A545-B846AF93F3D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C637860-B5BA-0C48-800E-BB79E18B2E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FBEDD6-49DC-654A-A168-4B0CCC870FD8}" type="datetimeFigureOut">
              <a:rPr lang="en-US" smtClean="0"/>
              <a:t>6/17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528804C-56CE-9047-B009-DE00577CA5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B1107E1-6F98-B34C-AD2C-39194788FD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764CBB-9AFA-824B-8396-095C3D994F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00644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4A45791-B64B-3745-A263-6F60EA7DF1D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04455BE-60E0-9948-AA9B-1CBAF803EF1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D8690FA-77AE-7541-BA63-1534BD5C6C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FBEDD6-49DC-654A-A168-4B0CCC870FD8}" type="datetimeFigureOut">
              <a:rPr lang="en-US" smtClean="0"/>
              <a:t>6/17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D9C9DE7-A5E6-5742-8BD9-DC47E15CEF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80EC649-E78E-5E47-A2A8-A5BDACEFC8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764CBB-9AFA-824B-8396-095C3D994F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7284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0858CA1-A1DF-644D-86F8-041F1EAF250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AD33383-B2AB-AF43-803C-C8537319A01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5D27C8D-54AE-8649-A21F-87A3C044C3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FBEDD6-49DC-654A-A168-4B0CCC870FD8}" type="datetimeFigureOut">
              <a:rPr lang="en-US" smtClean="0"/>
              <a:t>6/17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1E2A0B2-49DD-674E-94EC-D59322247E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A760BAE-4F14-0E48-88B5-0C2CAA82A3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764CBB-9AFA-824B-8396-095C3D994F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00018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7728DE2-D48C-C244-98FB-AE4944BE8B3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6CD90B4-C211-F347-9553-420DC254C88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33422F2-1B6E-5A4B-AB7A-FC33FEE6F5C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A8FD495-624C-FC4E-9C80-7036F336F9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FBEDD6-49DC-654A-A168-4B0CCC870FD8}" type="datetimeFigureOut">
              <a:rPr lang="en-US" smtClean="0"/>
              <a:t>6/17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43AE94B-7F3D-D444-87A4-9EB88BCED5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92014B0-45F6-7E43-BDEE-3166D00118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764CBB-9AFA-824B-8396-095C3D994F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18984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89EF25-F85C-FC4E-9655-E8F26EA88E3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2309BF3-15D2-0944-8332-2E331E2AC2D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6CD5D59-B20C-334B-85AE-87FD350147C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3613F3D-3B6B-1D43-92F2-8FCA11E0197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0B8A60C-5D6F-464B-8915-21A802AD573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08E43FF-D3A5-8244-9714-1188B21C0E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FBEDD6-49DC-654A-A168-4B0CCC870FD8}" type="datetimeFigureOut">
              <a:rPr lang="en-US" smtClean="0"/>
              <a:t>6/17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837690A-EAEA-0D4D-8C22-096D40713B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7537ED9-64E9-424F-AB35-90E7C355D9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764CBB-9AFA-824B-8396-095C3D994F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68387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A031D86-86D3-3247-BD26-F6C59C8C206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67D4190-365F-2747-812B-50EAED2AAA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FBEDD6-49DC-654A-A168-4B0CCC870FD8}" type="datetimeFigureOut">
              <a:rPr lang="en-US" smtClean="0"/>
              <a:t>6/17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81A90B9-2876-7547-B098-976EEAAFAE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BEC91D7-DC66-1241-828C-8507CA8E04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764CBB-9AFA-824B-8396-095C3D994F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15290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977A012-C4B3-EC48-8EAF-0E9743169A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FBEDD6-49DC-654A-A168-4B0CCC870FD8}" type="datetimeFigureOut">
              <a:rPr lang="en-US" smtClean="0"/>
              <a:t>6/17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79C525A-B830-1A4A-87C1-CAFF132B95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5F74E36-D18A-8C49-A7C6-3761FD8862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764CBB-9AFA-824B-8396-095C3D994F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11889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96F6870-709B-ED45-A731-74FBB14FACB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0DBA21A-6D1E-9D45-B344-351E4CD2B3C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EFE11F8-21DF-3741-9570-446C15B2898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7F3D56D-FA8B-F848-88E5-87E2E979F9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FBEDD6-49DC-654A-A168-4B0CCC870FD8}" type="datetimeFigureOut">
              <a:rPr lang="en-US" smtClean="0"/>
              <a:t>6/17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F879A07-3B09-864A-A538-344EF2E892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85C4FF6-3736-6947-A80E-5759121E70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764CBB-9AFA-824B-8396-095C3D994F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37711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4BF2EAB-2D03-D64D-A7E2-27CEEA365D8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B66F888-422D-A54B-9B4C-7361CDA1C98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5E55858-1676-574E-9465-3F75CEDDCDC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51AF57B-5BA3-4548-BD21-7BE9D7F844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FBEDD6-49DC-654A-A168-4B0CCC870FD8}" type="datetimeFigureOut">
              <a:rPr lang="en-US" smtClean="0"/>
              <a:t>6/17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DED6CEC-723A-5143-A600-D926F93A8D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9932411-2BDA-CD4F-90FC-D82DDF7EEB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764CBB-9AFA-824B-8396-095C3D994F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05551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EFAA2EC-85E7-3449-8650-EBAB498A711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398C689-B793-B449-AD5F-9A98BF928DD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59F56B0-60A4-7545-B967-8FAC9409495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FBEDD6-49DC-654A-A168-4B0CCC870FD8}" type="datetimeFigureOut">
              <a:rPr lang="en-US" smtClean="0"/>
              <a:t>6/17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7E340A3-AE86-3B42-8C79-BF9B8305AF9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F944CF9-AEED-0E4C-883F-5FF8DB9B2FF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764CBB-9AFA-824B-8396-095C3D994F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87308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Table 6">
            <a:extLst>
              <a:ext uri="{FF2B5EF4-FFF2-40B4-BE49-F238E27FC236}">
                <a16:creationId xmlns:a16="http://schemas.microsoft.com/office/drawing/2014/main" id="{5778D14A-FC5C-884D-9F0F-D0BE01ECFC4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09319601"/>
              </p:ext>
            </p:extLst>
          </p:nvPr>
        </p:nvGraphicFramePr>
        <p:xfrm>
          <a:off x="590550" y="1074960"/>
          <a:ext cx="11277600" cy="3484336"/>
        </p:xfrm>
        <a:graphic>
          <a:graphicData uri="http://schemas.openxmlformats.org/drawingml/2006/table">
            <a:tbl>
              <a:tblPr firstRow="1" firstCol="1" bandRow="1"/>
              <a:tblGrid>
                <a:gridCol w="2643304">
                  <a:extLst>
                    <a:ext uri="{9D8B030D-6E8A-4147-A177-3AD203B41FA5}">
                      <a16:colId xmlns:a16="http://schemas.microsoft.com/office/drawing/2014/main" val="2780643217"/>
                    </a:ext>
                  </a:extLst>
                </a:gridCol>
                <a:gridCol w="8634296">
                  <a:extLst>
                    <a:ext uri="{9D8B030D-6E8A-4147-A177-3AD203B41FA5}">
                      <a16:colId xmlns:a16="http://schemas.microsoft.com/office/drawing/2014/main" val="2283312588"/>
                    </a:ext>
                  </a:extLst>
                </a:gridCol>
              </a:tblGrid>
              <a:tr h="563336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meRAIVS (Cj NCTC 11168)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AGCCAAAAA</a:t>
                      </a:r>
                      <a:r>
                        <a:rPr lang="en-US" sz="16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TTTTGTAATAAATATTACA</a:t>
                      </a:r>
                      <a:r>
                        <a:rPr lang="en-US" sz="16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  <a:r>
                        <a:rPr lang="en-US" sz="16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TTTT</a:t>
                      </a:r>
                      <a:r>
                        <a:rPr lang="en-US" sz="16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ATTTAATTTTTCAAGGCAAAACC</a:t>
                      </a:r>
                      <a:endParaRPr lang="en-US" sz="16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04579764"/>
                  </a:ext>
                </a:extLst>
              </a:tr>
              <a:tr h="58420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7650 </a:t>
                      </a:r>
                      <a:r>
                        <a:rPr lang="en-US" sz="1600" dirty="0" err="1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meRAIVS</a:t>
                      </a:r>
                      <a:r>
                        <a:rPr lang="en-US" sz="16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(Type 0)</a:t>
                      </a:r>
                      <a:endParaRPr lang="en-US" sz="16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AGCCAAAAATTT</a:t>
                      </a:r>
                      <a:r>
                        <a:rPr lang="en-US" sz="1600" b="1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</a:t>
                      </a:r>
                      <a:r>
                        <a:rPr lang="en-US" sz="16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GTAATAAA</a:t>
                      </a:r>
                      <a:r>
                        <a:rPr lang="en-US" sz="1600" b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</a:t>
                      </a:r>
                      <a:r>
                        <a:rPr lang="en-US" sz="16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TTACAATTTTTAATTTAATTTTTCAAGGCAAAACC</a:t>
                      </a:r>
                      <a:endParaRPr lang="en-US" sz="16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59419676"/>
                  </a:ext>
                </a:extLst>
              </a:tr>
              <a:tr h="58420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7686 </a:t>
                      </a:r>
                      <a:r>
                        <a:rPr lang="en-US" sz="1600" dirty="0" err="1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meRAIVS</a:t>
                      </a:r>
                      <a:r>
                        <a:rPr lang="en-US" sz="16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(Type 0)</a:t>
                      </a:r>
                      <a:endParaRPr lang="en-US" sz="16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AGCCAAAAATTTTTGTAATAAA</a:t>
                      </a:r>
                      <a:r>
                        <a:rPr lang="en-US" sz="1600" b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</a:t>
                      </a:r>
                      <a:r>
                        <a:rPr lang="en-US" sz="16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TTACAATTTTTAATTTAATTTTTCAAGGCAAAACC</a:t>
                      </a:r>
                      <a:endParaRPr lang="en-US" sz="16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70937284"/>
                  </a:ext>
                </a:extLst>
              </a:tr>
              <a:tr h="58420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7688 </a:t>
                      </a:r>
                      <a:r>
                        <a:rPr lang="en-US" sz="1600" dirty="0" err="1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meRAIVS</a:t>
                      </a:r>
                      <a:r>
                        <a:rPr lang="en-US" sz="16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(Type 0)</a:t>
                      </a:r>
                      <a:endParaRPr lang="en-US" sz="16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AGCCAAAAATTT</a:t>
                      </a:r>
                      <a:r>
                        <a:rPr lang="en-US" sz="1600" b="1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</a:t>
                      </a:r>
                      <a:r>
                        <a:rPr lang="en-US" sz="16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GTAATAAA</a:t>
                      </a:r>
                      <a:r>
                        <a:rPr lang="en-US" sz="1600" b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</a:t>
                      </a:r>
                      <a:r>
                        <a:rPr lang="en-US" sz="16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TTACAATTTTTAATTTAATTTTTCAAGGCAAAACC</a:t>
                      </a:r>
                      <a:endParaRPr lang="en-US" sz="16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00634814"/>
                  </a:ext>
                </a:extLst>
              </a:tr>
              <a:tr h="58420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7689 </a:t>
                      </a:r>
                      <a:r>
                        <a:rPr lang="en-US" sz="1600" dirty="0" err="1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meRAIVS</a:t>
                      </a:r>
                      <a:r>
                        <a:rPr lang="en-US" sz="16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(Type 4)</a:t>
                      </a:r>
                      <a:endParaRPr lang="en-US" sz="16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AGCCAAAAATTTTTGTAATAAA</a:t>
                      </a:r>
                      <a:r>
                        <a:rPr lang="en-US" sz="1600" b="1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  <a:r>
                        <a:rPr lang="en-US" sz="16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TTACAATTTTTAATTTAATTTTTCAAGGCAAAACC</a:t>
                      </a:r>
                      <a:endParaRPr lang="en-US" sz="16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08955988"/>
                  </a:ext>
                </a:extLst>
              </a:tr>
              <a:tr h="58420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7690 </a:t>
                      </a:r>
                      <a:r>
                        <a:rPr lang="en-US" sz="1600" dirty="0" err="1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meRAIVS</a:t>
                      </a:r>
                      <a:r>
                        <a:rPr lang="en-US" sz="16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(Type 4)</a:t>
                      </a:r>
                      <a:endParaRPr lang="en-US" sz="16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AGCCAAAAATTTTTGTAATAAA</a:t>
                      </a:r>
                      <a:r>
                        <a:rPr lang="en-US" sz="1600" b="1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  <a:r>
                        <a:rPr lang="en-US" sz="16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TTACAATTTTTAATTTAATTTTTCAAGGCAAAACC</a:t>
                      </a:r>
                      <a:endParaRPr lang="en-US" sz="16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08585565"/>
                  </a:ext>
                </a:extLst>
              </a:tr>
            </a:tbl>
          </a:graphicData>
        </a:graphic>
      </p:graphicFrame>
      <p:sp>
        <p:nvSpPr>
          <p:cNvPr id="8" name="Rectangle 7">
            <a:extLst>
              <a:ext uri="{FF2B5EF4-FFF2-40B4-BE49-F238E27FC236}">
                <a16:creationId xmlns:a16="http://schemas.microsoft.com/office/drawing/2014/main" id="{815D1194-95B0-D240-9707-995E075CA661}"/>
              </a:ext>
            </a:extLst>
          </p:cNvPr>
          <p:cNvSpPr/>
          <p:nvPr/>
        </p:nvSpPr>
        <p:spPr>
          <a:xfrm>
            <a:off x="5148411" y="1353262"/>
            <a:ext cx="2057400" cy="3320946"/>
          </a:xfrm>
          <a:prstGeom prst="rect">
            <a:avLst/>
          </a:prstGeom>
          <a:noFill/>
          <a:ln w="31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CBF88FF-BDE6-6B49-AFBE-834FBE8F63FB}"/>
              </a:ext>
            </a:extLst>
          </p:cNvPr>
          <p:cNvSpPr txBox="1"/>
          <p:nvPr/>
        </p:nvSpPr>
        <p:spPr>
          <a:xfrm>
            <a:off x="4934125" y="973298"/>
            <a:ext cx="489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-46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762BC096-CB65-D542-AB1E-DFD39F29375F}"/>
              </a:ext>
            </a:extLst>
          </p:cNvPr>
          <p:cNvSpPr txBox="1"/>
          <p:nvPr/>
        </p:nvSpPr>
        <p:spPr>
          <a:xfrm>
            <a:off x="6923794" y="979528"/>
            <a:ext cx="489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-31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045BBB77-B3FB-164C-AC2C-AF5BE8CD4157}"/>
              </a:ext>
            </a:extLst>
          </p:cNvPr>
          <p:cNvSpPr txBox="1"/>
          <p:nvPr/>
        </p:nvSpPr>
        <p:spPr>
          <a:xfrm>
            <a:off x="3105370" y="992133"/>
            <a:ext cx="489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-60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FF3F03C2-706E-AE4B-AD5E-B50494A93544}"/>
              </a:ext>
            </a:extLst>
          </p:cNvPr>
          <p:cNvSpPr txBox="1"/>
          <p:nvPr/>
        </p:nvSpPr>
        <p:spPr>
          <a:xfrm>
            <a:off x="10909808" y="1029446"/>
            <a:ext cx="3770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-1</a:t>
            </a:r>
          </a:p>
        </p:txBody>
      </p: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E1776513-FD2A-A24B-B4CA-84EB66ADBE15}"/>
              </a:ext>
            </a:extLst>
          </p:cNvPr>
          <p:cNvCxnSpPr>
            <a:cxnSpLocks/>
          </p:cNvCxnSpPr>
          <p:nvPr/>
        </p:nvCxnSpPr>
        <p:spPr>
          <a:xfrm>
            <a:off x="5149700" y="1240425"/>
            <a:ext cx="0" cy="267669"/>
          </a:xfrm>
          <a:prstGeom prst="line">
            <a:avLst/>
          </a:prstGeom>
          <a:ln w="127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F8750DBE-5F09-1E44-AD6F-082E0251187A}"/>
              </a:ext>
            </a:extLst>
          </p:cNvPr>
          <p:cNvCxnSpPr>
            <a:cxnSpLocks/>
          </p:cNvCxnSpPr>
          <p:nvPr/>
        </p:nvCxnSpPr>
        <p:spPr>
          <a:xfrm>
            <a:off x="7217385" y="1232405"/>
            <a:ext cx="0" cy="267669"/>
          </a:xfrm>
          <a:prstGeom prst="line">
            <a:avLst/>
          </a:prstGeom>
          <a:ln w="127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TextBox 2">
            <a:extLst>
              <a:ext uri="{FF2B5EF4-FFF2-40B4-BE49-F238E27FC236}">
                <a16:creationId xmlns:a16="http://schemas.microsoft.com/office/drawing/2014/main" id="{F20F4E07-B1AE-5848-B0A0-CAA762139DA9}"/>
              </a:ext>
            </a:extLst>
          </p:cNvPr>
          <p:cNvSpPr txBox="1"/>
          <p:nvPr/>
        </p:nvSpPr>
        <p:spPr>
          <a:xfrm>
            <a:off x="396816" y="296529"/>
            <a:ext cx="1111082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>
                <a:solidFill>
                  <a:schemeClr val="accent1">
                    <a:lumMod val="7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1 Fig:  </a:t>
            </a:r>
            <a:r>
              <a:rPr lang="en-US" b="1" dirty="0">
                <a:solidFill>
                  <a:schemeClr val="accent1">
                    <a:lumMod val="7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lignment of intergenic region of </a:t>
            </a:r>
            <a:r>
              <a:rPr lang="en-US" b="1" i="1" dirty="0">
                <a:solidFill>
                  <a:schemeClr val="accent1">
                    <a:lumMod val="7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mpylobacter jejuni</a:t>
            </a:r>
            <a:r>
              <a:rPr lang="en-US" b="1" dirty="0">
                <a:solidFill>
                  <a:schemeClr val="accent1">
                    <a:lumMod val="7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b="1" dirty="0">
                <a:solidFill>
                  <a:schemeClr val="accent1">
                    <a:lumMod val="75000"/>
                  </a:schemeClr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NCTC 11168 reference strain with 5 ERY</a:t>
            </a:r>
            <a:r>
              <a:rPr lang="en-US" b="1" baseline="30000" dirty="0">
                <a:solidFill>
                  <a:schemeClr val="accent1">
                    <a:lumMod val="75000"/>
                  </a:schemeClr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US" b="1" dirty="0">
                <a:solidFill>
                  <a:schemeClr val="accent1">
                    <a:lumMod val="75000"/>
                  </a:schemeClr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b="1" i="1" dirty="0">
                <a:solidFill>
                  <a:schemeClr val="accent1">
                    <a:lumMod val="75000"/>
                  </a:schemeClr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. jejuni </a:t>
            </a:r>
            <a:r>
              <a:rPr lang="en-US" b="1" dirty="0">
                <a:solidFill>
                  <a:schemeClr val="accent1">
                    <a:lumMod val="7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solates. </a:t>
            </a:r>
          </a:p>
        </p:txBody>
      </p:sp>
    </p:spTree>
    <p:extLst>
      <p:ext uri="{BB962C8B-B14F-4D97-AF65-F5344CB8AC3E}">
        <p14:creationId xmlns:p14="http://schemas.microsoft.com/office/powerpoint/2010/main" val="19671467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3</TotalTime>
  <Words>72</Words>
  <Application>Microsoft Office PowerPoint</Application>
  <PresentationFormat>Widescreen</PresentationFormat>
  <Paragraphs>1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aimaa Mahmoud</dc:creator>
  <cp:lastModifiedBy>Sathish Kumar</cp:lastModifiedBy>
  <cp:revision>22</cp:revision>
  <dcterms:created xsi:type="dcterms:W3CDTF">2020-07-14T15:42:07Z</dcterms:created>
  <dcterms:modified xsi:type="dcterms:W3CDTF">2021-06-17T11:30:44Z</dcterms:modified>
</cp:coreProperties>
</file>